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2"/>
  </p:notesMasterIdLst>
  <p:sldIdLst>
    <p:sldId id="264" r:id="rId2"/>
    <p:sldId id="269" r:id="rId3"/>
    <p:sldId id="270" r:id="rId4"/>
    <p:sldId id="265" r:id="rId5"/>
    <p:sldId id="280" r:id="rId6"/>
    <p:sldId id="273" r:id="rId7"/>
    <p:sldId id="274" r:id="rId8"/>
    <p:sldId id="276" r:id="rId9"/>
    <p:sldId id="275" r:id="rId10"/>
    <p:sldId id="279" r:id="rId11"/>
  </p:sldIdLst>
  <p:sldSz cx="6480175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15" userDrawn="1">
          <p15:clr>
            <a:srgbClr val="A4A3A4"/>
          </p15:clr>
        </p15:guide>
        <p15:guide id="2" pos="2018" userDrawn="1">
          <p15:clr>
            <a:srgbClr val="A4A3A4"/>
          </p15:clr>
        </p15:guide>
        <p15:guide id="3" pos="219" userDrawn="1">
          <p15:clr>
            <a:srgbClr val="A4A3A4"/>
          </p15:clr>
        </p15:guide>
        <p15:guide id="4" orient="horz" pos="952" userDrawn="1">
          <p15:clr>
            <a:srgbClr val="A4A3A4"/>
          </p15:clr>
        </p15:guide>
        <p15:guide id="5" pos="3969" userDrawn="1">
          <p15:clr>
            <a:srgbClr val="A4A3A4"/>
          </p15:clr>
        </p15:guide>
        <p15:guide id="7" orient="horz" pos="113" userDrawn="1">
          <p15:clr>
            <a:srgbClr val="A4A3A4"/>
          </p15:clr>
        </p15:guide>
        <p15:guide id="8" pos="91" userDrawn="1">
          <p15:clr>
            <a:srgbClr val="A4A3A4"/>
          </p15:clr>
        </p15:guide>
        <p15:guide id="9" pos="3878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6505B2E-FB13-0167-6A5A-5A1C69785968}" name="Onuma Toshimichi" initials="OT" userId="3c02b7618b88d217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中間スタイル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12"/>
    <p:restoredTop sz="95918"/>
  </p:normalViewPr>
  <p:slideViewPr>
    <p:cSldViewPr snapToGrid="0">
      <p:cViewPr varScale="1">
        <p:scale>
          <a:sx n="181" d="100"/>
          <a:sy n="181" d="100"/>
        </p:scale>
        <p:origin x="1976" y="200"/>
      </p:cViewPr>
      <p:guideLst>
        <p:guide orient="horz" pos="5715"/>
        <p:guide pos="2018"/>
        <p:guide pos="219"/>
        <p:guide orient="horz" pos="952"/>
        <p:guide pos="3969"/>
        <p:guide orient="horz" pos="113"/>
        <p:guide pos="91"/>
        <p:guide pos="387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microsoft.com/office/2018/10/relationships/authors" Target="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CA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5DF5D5-450A-4648-8BF2-6E47D0B185C0}" type="datetimeFigureOut">
              <a:rPr kumimoji="1" lang="ja-CA" altLang="en-US" smtClean="0"/>
              <a:t>5/16/24</a:t>
            </a:fld>
            <a:endParaRPr kumimoji="1" lang="ja-CA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35213" y="1143000"/>
            <a:ext cx="2187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CA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CA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CA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DAE695-6FAB-9040-8525-E8322CFB51F0}" type="slidenum">
              <a:rPr kumimoji="1" lang="ja-CA" altLang="en-US" smtClean="0"/>
              <a:t>‹#›</a:t>
            </a:fld>
            <a:endParaRPr kumimoji="1" lang="ja-CA" altLang="en-US"/>
          </a:p>
        </p:txBody>
      </p:sp>
    </p:spTree>
    <p:extLst>
      <p:ext uri="{BB962C8B-B14F-4D97-AF65-F5344CB8AC3E}">
        <p14:creationId xmlns:p14="http://schemas.microsoft.com/office/powerpoint/2010/main" val="42455173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DAE695-6FAB-9040-8525-E8322CFB51F0}" type="slidenum">
              <a:rPr kumimoji="1" lang="ja-CA" altLang="en-US" smtClean="0"/>
              <a:t>10</a:t>
            </a:fld>
            <a:endParaRPr kumimoji="1" lang="ja-CA" altLang="en-US"/>
          </a:p>
        </p:txBody>
      </p:sp>
    </p:spTree>
    <p:extLst>
      <p:ext uri="{BB962C8B-B14F-4D97-AF65-F5344CB8AC3E}">
        <p14:creationId xmlns:p14="http://schemas.microsoft.com/office/powerpoint/2010/main" val="38631089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496484"/>
            <a:ext cx="5508149" cy="3183467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802717"/>
            <a:ext cx="4860131" cy="2207683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81B72-1D30-5A43-8183-FED9BE9F6F5B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1A71E-0E81-F54B-A34F-F5BA75A4E3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1255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81B72-1D30-5A43-8183-FED9BE9F6F5B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1A71E-0E81-F54B-A34F-F5BA75A4E3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9844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86834"/>
            <a:ext cx="1397288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86834"/>
            <a:ext cx="4110861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81B72-1D30-5A43-8183-FED9BE9F6F5B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1A71E-0E81-F54B-A34F-F5BA75A4E3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839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81B72-1D30-5A43-8183-FED9BE9F6F5B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1A71E-0E81-F54B-A34F-F5BA75A4E3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14758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279653"/>
            <a:ext cx="5589151" cy="3803649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119286"/>
            <a:ext cx="5589151" cy="2000249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81B72-1D30-5A43-8183-FED9BE9F6F5B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1A71E-0E81-F54B-A34F-F5BA75A4E3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434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434167"/>
            <a:ext cx="2754074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434167"/>
            <a:ext cx="2754074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81B72-1D30-5A43-8183-FED9BE9F6F5B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1A71E-0E81-F54B-A34F-F5BA75A4E3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2027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86836"/>
            <a:ext cx="5589151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241551"/>
            <a:ext cx="2741417" cy="1098549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340100"/>
            <a:ext cx="2741417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241551"/>
            <a:ext cx="2754918" cy="1098549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340100"/>
            <a:ext cx="2754918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81B72-1D30-5A43-8183-FED9BE9F6F5B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1A71E-0E81-F54B-A34F-F5BA75A4E3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5053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81B72-1D30-5A43-8183-FED9BE9F6F5B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1A71E-0E81-F54B-A34F-F5BA75A4E3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139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81B72-1D30-5A43-8183-FED9BE9F6F5B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1A71E-0E81-F54B-A34F-F5BA75A4E3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8403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09600"/>
            <a:ext cx="2090025" cy="21336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316569"/>
            <a:ext cx="3280589" cy="6498167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743200"/>
            <a:ext cx="2090025" cy="508211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81B72-1D30-5A43-8183-FED9BE9F6F5B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1A71E-0E81-F54B-A34F-F5BA75A4E3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1306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09600"/>
            <a:ext cx="2090025" cy="21336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316569"/>
            <a:ext cx="3280589" cy="6498167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743200"/>
            <a:ext cx="2090025" cy="508211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81B72-1D30-5A43-8183-FED9BE9F6F5B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1A71E-0E81-F54B-A34F-F5BA75A4E3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16344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86836"/>
            <a:ext cx="5589151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434167"/>
            <a:ext cx="5589151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8475136"/>
            <a:ext cx="145803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D81B72-1D30-5A43-8183-FED9BE9F6F5B}" type="datetimeFigureOut">
              <a:rPr kumimoji="1" lang="ja-JP" altLang="en-US" smtClean="0"/>
              <a:t>2024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8475136"/>
            <a:ext cx="218705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8475136"/>
            <a:ext cx="145803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21A71E-0E81-F54B-A34F-F5BA75A4E3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5596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BC9126C-824E-29AE-660F-9E83A83E3735}"/>
              </a:ext>
            </a:extLst>
          </p:cNvPr>
          <p:cNvSpPr txBox="1"/>
          <p:nvPr/>
        </p:nvSpPr>
        <p:spPr>
          <a:xfrm>
            <a:off x="573663" y="2714493"/>
            <a:ext cx="533284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" altLang="ja-CA" dirty="0">
                <a:latin typeface="Arial" panose="020B0604020202020204" pitchFamily="34" charset="0"/>
                <a:cs typeface="Arial" panose="020B0604020202020204" pitchFamily="34" charset="0"/>
              </a:rPr>
              <a:t>Plasma Gelsolin Inhibits Natural Killer Cell Function and confers Chemoresistance in Epithelial Ovarian Cancer</a:t>
            </a:r>
          </a:p>
          <a:p>
            <a:pPr algn="ctr"/>
            <a:r>
              <a:rPr kumimoji="1" lang="en" altLang="ja-CA" dirty="0">
                <a:latin typeface="Arial" panose="020B0604020202020204" pitchFamily="34" charset="0"/>
                <a:cs typeface="Arial" panose="020B0604020202020204" pitchFamily="34" charset="0"/>
              </a:rPr>
              <a:t>Supplemental Table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7B64113-781A-A7AA-B72B-517F3E963B1D}"/>
              </a:ext>
            </a:extLst>
          </p:cNvPr>
          <p:cNvSpPr txBox="1"/>
          <p:nvPr/>
        </p:nvSpPr>
        <p:spPr>
          <a:xfrm>
            <a:off x="2052636" y="5078968"/>
            <a:ext cx="2374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err="1">
                <a:latin typeface="Arial" panose="020B0604020202020204" pitchFamily="34" charset="0"/>
                <a:cs typeface="Arial" panose="020B0604020202020204" pitchFamily="34" charset="0"/>
              </a:rPr>
              <a:t>Toshimichi</a:t>
            </a:r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err="1">
                <a:latin typeface="Arial" panose="020B0604020202020204" pitchFamily="34" charset="0"/>
                <a:cs typeface="Arial" panose="020B0604020202020204" pitchFamily="34" charset="0"/>
              </a:rPr>
              <a:t>Onum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645027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DFF9325-6D67-0E4D-B875-B9BFDB0FA255}"/>
              </a:ext>
            </a:extLst>
          </p:cNvPr>
          <p:cNvSpPr txBox="1"/>
          <p:nvPr/>
        </p:nvSpPr>
        <p:spPr>
          <a:xfrm>
            <a:off x="61101" y="369692"/>
            <a:ext cx="45958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CA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11 Univariate Cox regression analysis for PFS </a:t>
            </a:r>
            <a:endParaRPr kumimoji="1" lang="ja-CA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2A9D3278-CA04-3C85-869A-5FBA0CB52B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3266037"/>
              </p:ext>
            </p:extLst>
          </p:nvPr>
        </p:nvGraphicFramePr>
        <p:xfrm>
          <a:off x="84134" y="742915"/>
          <a:ext cx="6338890" cy="207395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87979">
                  <a:extLst>
                    <a:ext uri="{9D8B030D-6E8A-4147-A177-3AD203B41FA5}">
                      <a16:colId xmlns:a16="http://schemas.microsoft.com/office/drawing/2014/main" val="1922469106"/>
                    </a:ext>
                  </a:extLst>
                </a:gridCol>
                <a:gridCol w="436369">
                  <a:extLst>
                    <a:ext uri="{9D8B030D-6E8A-4147-A177-3AD203B41FA5}">
                      <a16:colId xmlns:a16="http://schemas.microsoft.com/office/drawing/2014/main" val="2977902610"/>
                    </a:ext>
                  </a:extLst>
                </a:gridCol>
                <a:gridCol w="771258">
                  <a:extLst>
                    <a:ext uri="{9D8B030D-6E8A-4147-A177-3AD203B41FA5}">
                      <a16:colId xmlns:a16="http://schemas.microsoft.com/office/drawing/2014/main" val="1356211174"/>
                    </a:ext>
                  </a:extLst>
                </a:gridCol>
                <a:gridCol w="545462">
                  <a:extLst>
                    <a:ext uri="{9D8B030D-6E8A-4147-A177-3AD203B41FA5}">
                      <a16:colId xmlns:a16="http://schemas.microsoft.com/office/drawing/2014/main" val="4146463045"/>
                    </a:ext>
                  </a:extLst>
                </a:gridCol>
                <a:gridCol w="436369">
                  <a:extLst>
                    <a:ext uri="{9D8B030D-6E8A-4147-A177-3AD203B41FA5}">
                      <a16:colId xmlns:a16="http://schemas.microsoft.com/office/drawing/2014/main" val="1604378178"/>
                    </a:ext>
                  </a:extLst>
                </a:gridCol>
                <a:gridCol w="641423">
                  <a:extLst>
                    <a:ext uri="{9D8B030D-6E8A-4147-A177-3AD203B41FA5}">
                      <a16:colId xmlns:a16="http://schemas.microsoft.com/office/drawing/2014/main" val="812381885"/>
                    </a:ext>
                  </a:extLst>
                </a:gridCol>
                <a:gridCol w="545462">
                  <a:extLst>
                    <a:ext uri="{9D8B030D-6E8A-4147-A177-3AD203B41FA5}">
                      <a16:colId xmlns:a16="http://schemas.microsoft.com/office/drawing/2014/main" val="2063579368"/>
                    </a:ext>
                  </a:extLst>
                </a:gridCol>
                <a:gridCol w="436369">
                  <a:extLst>
                    <a:ext uri="{9D8B030D-6E8A-4147-A177-3AD203B41FA5}">
                      <a16:colId xmlns:a16="http://schemas.microsoft.com/office/drawing/2014/main" val="460422777"/>
                    </a:ext>
                  </a:extLst>
                </a:gridCol>
                <a:gridCol w="692737">
                  <a:extLst>
                    <a:ext uri="{9D8B030D-6E8A-4147-A177-3AD203B41FA5}">
                      <a16:colId xmlns:a16="http://schemas.microsoft.com/office/drawing/2014/main" val="1638911775"/>
                    </a:ext>
                  </a:extLst>
                </a:gridCol>
                <a:gridCol w="545462">
                  <a:extLst>
                    <a:ext uri="{9D8B030D-6E8A-4147-A177-3AD203B41FA5}">
                      <a16:colId xmlns:a16="http://schemas.microsoft.com/office/drawing/2014/main" val="140295944"/>
                    </a:ext>
                  </a:extLst>
                </a:gridCol>
              </a:tblGrid>
              <a:tr h="131516">
                <a:tc>
                  <a:txBody>
                    <a:bodyPr/>
                    <a:lstStyle/>
                    <a:p>
                      <a:pPr algn="l" fontAlgn="ctr"/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All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on-residual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Residual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9856082"/>
                  </a:ext>
                </a:extLst>
              </a:tr>
              <a:tr h="1315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Variable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HR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5% CI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P value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HR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 95% CI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P value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HR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5% CI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P value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3308508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Age ≤56 vs. &gt;56 years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03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17–3.521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118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133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4743–2.707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7787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512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6655–3.436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3234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63126784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FIGO stage ≤2 vs. &gt;2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902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734–8.79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&lt;0.0001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307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9001–5.915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8172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405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4576–25.34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2315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54978288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FIGO stage ≤3 vs. &gt;3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319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7–6.482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004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519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7264–3.176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2668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1161826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RD  ≤1 vs. &gt;1 cm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.051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907–8.776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&lt;0.0001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05847684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pGSN epi low vs. high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732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9854–7.576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534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725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6361–11.67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1769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6777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318–1.444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3136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70224580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CR1 epi low vs. high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1078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149–0.78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274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2228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2993–1.658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1425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3581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1367–0.938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366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53287298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pGSN str low vs. high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72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9558–3.094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704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356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015–5.466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461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4027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1221–1.328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1352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46771179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CR1 str low vs. high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6463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3247–1.287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214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4014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1628–0.9896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474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3581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1367–0.938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366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8638636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Serous vs. non-serous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88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04–5.99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001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44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055–5.661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371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186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4489–3.134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7308</a:t>
                      </a:r>
                      <a:endParaRPr 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9011262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32410F2-706D-5EFA-F62C-21CC20A7DEC5}"/>
              </a:ext>
            </a:extLst>
          </p:cNvPr>
          <p:cNvSpPr txBox="1"/>
          <p:nvPr/>
        </p:nvSpPr>
        <p:spPr>
          <a:xfrm>
            <a:off x="84134" y="2914920"/>
            <a:ext cx="633889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: hazard ratio; CI: confidence interval; FIGO: Federation </a:t>
            </a:r>
            <a:r>
              <a:rPr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nationale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 </a:t>
            </a:r>
            <a:r>
              <a:rPr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necologie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</a:t>
            </a:r>
            <a:r>
              <a:rPr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‘Obstetrique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RD: residual disease; pGSN: plasma gelsolin; NCR1: natural cytotoxicity triggering receptor 1; epi: epithelial; str: stromal</a:t>
            </a:r>
            <a:endParaRPr lang="ja-JP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5497E8E-DD74-DCBF-353D-76BF32F598FE}"/>
              </a:ext>
            </a:extLst>
          </p:cNvPr>
          <p:cNvSpPr txBox="1"/>
          <p:nvPr/>
        </p:nvSpPr>
        <p:spPr>
          <a:xfrm>
            <a:off x="84134" y="3970142"/>
            <a:ext cx="45958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CA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12 Univariate Cox regression analysis for OS </a:t>
            </a:r>
            <a:endParaRPr kumimoji="1" lang="ja-CA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59E25D7F-783E-F845-8B22-FB75E549BF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1292906"/>
              </p:ext>
            </p:extLst>
          </p:nvPr>
        </p:nvGraphicFramePr>
        <p:xfrm>
          <a:off x="107167" y="4343365"/>
          <a:ext cx="6338890" cy="194244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87979">
                  <a:extLst>
                    <a:ext uri="{9D8B030D-6E8A-4147-A177-3AD203B41FA5}">
                      <a16:colId xmlns:a16="http://schemas.microsoft.com/office/drawing/2014/main" val="1922469106"/>
                    </a:ext>
                  </a:extLst>
                </a:gridCol>
                <a:gridCol w="436369">
                  <a:extLst>
                    <a:ext uri="{9D8B030D-6E8A-4147-A177-3AD203B41FA5}">
                      <a16:colId xmlns:a16="http://schemas.microsoft.com/office/drawing/2014/main" val="2977902610"/>
                    </a:ext>
                  </a:extLst>
                </a:gridCol>
                <a:gridCol w="771258">
                  <a:extLst>
                    <a:ext uri="{9D8B030D-6E8A-4147-A177-3AD203B41FA5}">
                      <a16:colId xmlns:a16="http://schemas.microsoft.com/office/drawing/2014/main" val="1356211174"/>
                    </a:ext>
                  </a:extLst>
                </a:gridCol>
                <a:gridCol w="545462">
                  <a:extLst>
                    <a:ext uri="{9D8B030D-6E8A-4147-A177-3AD203B41FA5}">
                      <a16:colId xmlns:a16="http://schemas.microsoft.com/office/drawing/2014/main" val="4146463045"/>
                    </a:ext>
                  </a:extLst>
                </a:gridCol>
                <a:gridCol w="436369">
                  <a:extLst>
                    <a:ext uri="{9D8B030D-6E8A-4147-A177-3AD203B41FA5}">
                      <a16:colId xmlns:a16="http://schemas.microsoft.com/office/drawing/2014/main" val="1604378178"/>
                    </a:ext>
                  </a:extLst>
                </a:gridCol>
                <a:gridCol w="641423">
                  <a:extLst>
                    <a:ext uri="{9D8B030D-6E8A-4147-A177-3AD203B41FA5}">
                      <a16:colId xmlns:a16="http://schemas.microsoft.com/office/drawing/2014/main" val="812381885"/>
                    </a:ext>
                  </a:extLst>
                </a:gridCol>
                <a:gridCol w="545462">
                  <a:extLst>
                    <a:ext uri="{9D8B030D-6E8A-4147-A177-3AD203B41FA5}">
                      <a16:colId xmlns:a16="http://schemas.microsoft.com/office/drawing/2014/main" val="2063579368"/>
                    </a:ext>
                  </a:extLst>
                </a:gridCol>
                <a:gridCol w="436369">
                  <a:extLst>
                    <a:ext uri="{9D8B030D-6E8A-4147-A177-3AD203B41FA5}">
                      <a16:colId xmlns:a16="http://schemas.microsoft.com/office/drawing/2014/main" val="460422777"/>
                    </a:ext>
                  </a:extLst>
                </a:gridCol>
                <a:gridCol w="692737">
                  <a:extLst>
                    <a:ext uri="{9D8B030D-6E8A-4147-A177-3AD203B41FA5}">
                      <a16:colId xmlns:a16="http://schemas.microsoft.com/office/drawing/2014/main" val="1638911775"/>
                    </a:ext>
                  </a:extLst>
                </a:gridCol>
                <a:gridCol w="545462">
                  <a:extLst>
                    <a:ext uri="{9D8B030D-6E8A-4147-A177-3AD203B41FA5}">
                      <a16:colId xmlns:a16="http://schemas.microsoft.com/office/drawing/2014/main" val="140295944"/>
                    </a:ext>
                  </a:extLst>
                </a:gridCol>
              </a:tblGrid>
              <a:tr h="131516">
                <a:tc>
                  <a:txBody>
                    <a:bodyPr/>
                    <a:lstStyle/>
                    <a:p>
                      <a:pPr algn="l" fontAlgn="ctr"/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All</a:t>
                      </a:r>
                    </a:p>
                  </a:txBody>
                  <a:tcPr marL="6825" marR="6825" marT="68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 residual</a:t>
                      </a:r>
                      <a:endParaRPr kumimoji="1" lang="ja-JP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al</a:t>
                      </a:r>
                      <a:endParaRPr kumimoji="1" lang="ja-JP" altLang="en-US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9856082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CI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95%CI</a:t>
                      </a:r>
                      <a:endParaRPr kumimoji="1" lang="ja-JP" altLang="en-US"/>
                    </a:p>
                  </a:txBody>
                  <a:tcPr marL="6825" marR="6825" marT="68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CI</a:t>
                      </a:r>
                      <a:endParaRPr kumimoji="1" lang="ja-JP" altLang="en-US"/>
                    </a:p>
                  </a:txBody>
                  <a:tcPr marL="6825" marR="6825" marT="68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63126784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≦56 vs &gt;56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97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32-5.063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1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27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83-3.447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43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59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68-6.096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78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extLst>
                  <a:ext uri="{0D108BD9-81ED-4DB2-BD59-A6C34878D82A}">
                    <a16:rowId xmlns:a16="http://schemas.microsoft.com/office/drawing/2014/main" val="1454978288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O Stage ≦2 vs ＞2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91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91-8.404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9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73-5.714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656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42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65-7.957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31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extLst>
                  <a:ext uri="{0D108BD9-81ED-4DB2-BD59-A6C34878D82A}">
                    <a16:rowId xmlns:a16="http://schemas.microsoft.com/office/drawing/2014/main" val="201161826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D  ≦1cm vs &gt;1cm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43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87-11.03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extLst>
                  <a:ext uri="{0D108BD9-81ED-4DB2-BD59-A6C34878D82A}">
                    <a16:rowId xmlns:a16="http://schemas.microsoft.com/office/drawing/2014/main" val="1805847684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SN</a:t>
                      </a:r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pi Low vs High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96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28-26.24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69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410000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-inf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77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3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7-3.805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25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extLst>
                  <a:ext uri="{0D108BD9-81ED-4DB2-BD59-A6C34878D82A}">
                    <a16:rowId xmlns:a16="http://schemas.microsoft.com/office/drawing/2014/main" val="1170224580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R1 epi Low vs High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73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6-31.16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19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59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29-4.383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641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78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3-1.49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73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extLst>
                  <a:ext uri="{0D108BD9-81ED-4DB2-BD59-A6C34878D82A}">
                    <a16:rowId xmlns:a16="http://schemas.microsoft.com/office/drawing/2014/main" val="2653287298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SN</a:t>
                      </a:r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r  Low vs High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3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21-3.231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18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57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8-3.542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83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16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62-4.363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19</a:t>
                      </a:r>
                      <a:endParaRPr lang="en-US" altLang="ja-JP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extLst>
                  <a:ext uri="{0D108BD9-81ED-4DB2-BD59-A6C34878D82A}">
                    <a16:rowId xmlns:a16="http://schemas.microsoft.com/office/drawing/2014/main" val="3546771179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R1 str Low vs High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825" marR="6825" marT="68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551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83-47.77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37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25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51-1.469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40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074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15-1.096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54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/>
                </a:tc>
                <a:extLst>
                  <a:ext uri="{0D108BD9-81ED-4DB2-BD59-A6C34878D82A}">
                    <a16:rowId xmlns:a16="http://schemas.microsoft.com/office/drawing/2014/main" val="168638636"/>
                  </a:ext>
                </a:extLst>
              </a:tr>
              <a:tr h="20121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ous vs Non Serous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82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7-4.463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9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92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89-3.653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86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11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3-2.987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52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6196" marR="6196" marT="6196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9011262"/>
                  </a:ext>
                </a:extLst>
              </a:tr>
            </a:tbl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3F7B1A4-539F-E0A5-3E98-E76AD807C6B6}"/>
              </a:ext>
            </a:extLst>
          </p:cNvPr>
          <p:cNvSpPr txBox="1"/>
          <p:nvPr/>
        </p:nvSpPr>
        <p:spPr>
          <a:xfrm>
            <a:off x="107167" y="6515370"/>
            <a:ext cx="633889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: hazard ratio; CI: confidence interval; FIGO: Federation </a:t>
            </a:r>
            <a:r>
              <a:rPr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nationale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 </a:t>
            </a:r>
            <a:r>
              <a:rPr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necologie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</a:t>
            </a:r>
            <a:r>
              <a:rPr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'Obstetrique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RD: residual disease; pGSN: plasma gelsolin; NCR1: natural cytotoxicity triggering </a:t>
            </a:r>
            <a:r>
              <a:rPr lang="en-US" altLang="ja-JP" sz="800">
                <a:latin typeface="Times New Roman" panose="02020603050405020304" pitchFamily="18" charset="0"/>
                <a:cs typeface="Times New Roman" panose="02020603050405020304" pitchFamily="18" charset="0"/>
              </a:rPr>
              <a:t>receptor 1; epi: epithelial; str: stromal</a:t>
            </a:r>
            <a:endParaRPr lang="ja-JP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77372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29B5239-0B85-5E3C-F1A5-00FFC0D7AD89}"/>
              </a:ext>
            </a:extLst>
          </p:cNvPr>
          <p:cNvSpPr txBox="1"/>
          <p:nvPr/>
        </p:nvSpPr>
        <p:spPr>
          <a:xfrm>
            <a:off x="70642" y="413008"/>
            <a:ext cx="2667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CA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Patient characteristic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endParaRPr kumimoji="1" lang="ja-CA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AA18291C-BD46-2C70-1AF7-45402DD27E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934994"/>
              </p:ext>
            </p:extLst>
          </p:nvPr>
        </p:nvGraphicFramePr>
        <p:xfrm>
          <a:off x="523925" y="730410"/>
          <a:ext cx="2502672" cy="293569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251336">
                  <a:extLst>
                    <a:ext uri="{9D8B030D-6E8A-4147-A177-3AD203B41FA5}">
                      <a16:colId xmlns:a16="http://schemas.microsoft.com/office/drawing/2014/main" val="1133624793"/>
                    </a:ext>
                  </a:extLst>
                </a:gridCol>
                <a:gridCol w="1251336">
                  <a:extLst>
                    <a:ext uri="{9D8B030D-6E8A-4147-A177-3AD203B41FA5}">
                      <a16:colId xmlns:a16="http://schemas.microsoft.com/office/drawing/2014/main" val="707380319"/>
                    </a:ext>
                  </a:extLst>
                </a:gridCol>
              </a:tblGrid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47</a:t>
                      </a:r>
                      <a:endParaRPr lang="ja-CA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584502338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(mean)±SD year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0±12.2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extLst>
                  <a:ext uri="{0D108BD9-81ED-4DB2-BD59-A6C34878D82A}">
                    <a16:rowId xmlns:a16="http://schemas.microsoft.com/office/drawing/2014/main" val="3083313147"/>
                  </a:ext>
                </a:extLst>
              </a:tr>
              <a:tr h="165826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ge n(%)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 hMerge="1">
                  <a:txBody>
                    <a:bodyPr/>
                    <a:lstStyle/>
                    <a:p>
                      <a:endParaRPr lang="ja-CA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9306566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Ⅰ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(50.3)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extLst>
                  <a:ext uri="{0D108BD9-81ED-4DB2-BD59-A6C34878D82A}">
                    <a16:rowId xmlns:a16="http://schemas.microsoft.com/office/drawing/2014/main" val="3081171909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Ⅱ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(10.9)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extLst>
                  <a:ext uri="{0D108BD9-81ED-4DB2-BD59-A6C34878D82A}">
                    <a16:rowId xmlns:a16="http://schemas.microsoft.com/office/drawing/2014/main" val="2300722444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Ⅲ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(27.9)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extLst>
                  <a:ext uri="{0D108BD9-81ED-4DB2-BD59-A6C34878D82A}">
                    <a16:rowId xmlns:a16="http://schemas.microsoft.com/office/drawing/2014/main" val="654747651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Ⅳ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(10.9)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extLst>
                  <a:ext uri="{0D108BD9-81ED-4DB2-BD59-A6C34878D82A}">
                    <a16:rowId xmlns:a16="http://schemas.microsoft.com/office/drawing/2014/main" val="2497084074"/>
                  </a:ext>
                </a:extLst>
              </a:tr>
              <a:tr h="165826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stology n(%)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 hMerge="1">
                  <a:txBody>
                    <a:bodyPr/>
                    <a:lstStyle/>
                    <a:p>
                      <a:endParaRPr lang="ja-CA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5332194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High grade Serous carcinoma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(47.6)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extLst>
                  <a:ext uri="{0D108BD9-81ED-4DB2-BD59-A6C34878D82A}">
                    <a16:rowId xmlns:a16="http://schemas.microsoft.com/office/drawing/2014/main" val="3219120136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ndometrioid carcinoma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(14.3)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extLst>
                  <a:ext uri="{0D108BD9-81ED-4DB2-BD59-A6C34878D82A}">
                    <a16:rowId xmlns:a16="http://schemas.microsoft.com/office/drawing/2014/main" val="2397249594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lear carcinoma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(27.2)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extLst>
                  <a:ext uri="{0D108BD9-81ED-4DB2-BD59-A6C34878D82A}">
                    <a16:rowId xmlns:a16="http://schemas.microsoft.com/office/drawing/2014/main" val="3995110794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Mucinous carcinoma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(10.9)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extLst>
                  <a:ext uri="{0D108BD9-81ED-4DB2-BD59-A6C34878D82A}">
                    <a16:rowId xmlns:a16="http://schemas.microsoft.com/office/drawing/2014/main" val="2694106592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timal surgery n(% )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(68.7)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extLst>
                  <a:ext uri="{0D108BD9-81ED-4DB2-BD59-A6C34878D82A}">
                    <a16:rowId xmlns:a16="http://schemas.microsoft.com/office/drawing/2014/main" val="2606820051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S (median) month</a:t>
                      </a:r>
                      <a:endParaRPr lang="en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extLst>
                  <a:ext uri="{0D108BD9-81ED-4DB2-BD59-A6C34878D82A}">
                    <a16:rowId xmlns:a16="http://schemas.microsoft.com/office/drawing/2014/main" val="3792994420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currence (%)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(36.1)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extLst>
                  <a:ext uri="{0D108BD9-81ED-4DB2-BD59-A6C34878D82A}">
                    <a16:rowId xmlns:a16="http://schemas.microsoft.com/office/drawing/2014/main" val="2160369738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 (median) month</a:t>
                      </a:r>
                      <a:endParaRPr lang="en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/>
                </a:tc>
                <a:extLst>
                  <a:ext uri="{0D108BD9-81ED-4DB2-BD59-A6C34878D82A}">
                    <a16:rowId xmlns:a16="http://schemas.microsoft.com/office/drawing/2014/main" val="2139274045"/>
                  </a:ext>
                </a:extLst>
              </a:tr>
              <a:tr h="165826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ad (%)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CA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(26.5)</a:t>
                      </a:r>
                      <a:endParaRPr lang="en-US" altLang="ja-CA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156" marR="8156" marT="8156" marB="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9596100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2973D2B-D2FB-8C11-9145-7634903EB2AA}"/>
              </a:ext>
            </a:extLst>
          </p:cNvPr>
          <p:cNvSpPr txBox="1"/>
          <p:nvPr/>
        </p:nvSpPr>
        <p:spPr>
          <a:xfrm>
            <a:off x="144463" y="4773612"/>
            <a:ext cx="3736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CA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2 Inclusion and exclusion criteria</a:t>
            </a:r>
            <a:endParaRPr kumimoji="1" lang="ja-CA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B810FB39-BD99-CAFF-A440-FCF3ABCF8F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7055262"/>
              </p:ext>
            </p:extLst>
          </p:nvPr>
        </p:nvGraphicFramePr>
        <p:xfrm>
          <a:off x="195264" y="5351462"/>
          <a:ext cx="6156324" cy="1580516"/>
        </p:xfrm>
        <a:graphic>
          <a:graphicData uri="http://schemas.openxmlformats.org/drawingml/2006/table">
            <a:tbl>
              <a:tblPr>
                <a:tableStyleId>{85BE263C-DBD7-4A20-BB59-AAB30ACAA65A}</a:tableStyleId>
              </a:tblPr>
              <a:tblGrid>
                <a:gridCol w="2884444">
                  <a:extLst>
                    <a:ext uri="{9D8B030D-6E8A-4147-A177-3AD203B41FA5}">
                      <a16:colId xmlns:a16="http://schemas.microsoft.com/office/drawing/2014/main" val="1794131343"/>
                    </a:ext>
                  </a:extLst>
                </a:gridCol>
                <a:gridCol w="3271880">
                  <a:extLst>
                    <a:ext uri="{9D8B030D-6E8A-4147-A177-3AD203B41FA5}">
                      <a16:colId xmlns:a16="http://schemas.microsoft.com/office/drawing/2014/main" val="2932898812"/>
                    </a:ext>
                  </a:extLst>
                </a:gridCol>
              </a:tblGrid>
              <a:tr h="395129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lusion criteria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Exclusion criteria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6702995"/>
                  </a:ext>
                </a:extLst>
              </a:tr>
              <a:tr h="395129">
                <a:tc>
                  <a:txBody>
                    <a:bodyPr/>
                    <a:lstStyle/>
                    <a:p>
                      <a:pPr algn="l" fontAlgn="ctr"/>
                      <a:r>
                        <a:rPr lang="en" altLang="ja-CA" sz="9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varian, fallopian tube, or peritoneal epithelial cancer that has been histologically confirmed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    Patients being treated for other invasive cancer</a:t>
                      </a:r>
                    </a:p>
                    <a:p>
                      <a:pPr algn="l" fontAlgn="ctr"/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575082536"/>
                  </a:ext>
                </a:extLst>
              </a:tr>
              <a:tr h="395129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 ≥20 years of age.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    Patients </a:t>
                      </a:r>
                      <a:r>
                        <a:rPr lang="en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judged ineligible by Investigators</a:t>
                      </a:r>
                    </a:p>
                    <a:p>
                      <a:pPr algn="l" fontAlgn="ctr"/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8077510"/>
                  </a:ext>
                </a:extLst>
              </a:tr>
              <a:tr h="395129"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COG performance status 0-2.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76461970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B8586FE-29E9-8781-D6F5-0BEDB2DDC84C}"/>
              </a:ext>
            </a:extLst>
          </p:cNvPr>
          <p:cNvSpPr txBox="1"/>
          <p:nvPr/>
        </p:nvSpPr>
        <p:spPr>
          <a:xfrm>
            <a:off x="441375" y="3682932"/>
            <a:ext cx="324326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FS: progression-free survival; O</a:t>
            </a: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: </a:t>
            </a:r>
            <a:r>
              <a:rPr kumimoji="0" lang="en-US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erall </a:t>
            </a:r>
            <a:r>
              <a:rPr kumimoji="0" lang="ja-JP" altLang="ja-JP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rvival.</a:t>
            </a:r>
            <a:endParaRPr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67597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4FC713F-598E-6790-7031-A7AB3F1D8691}"/>
              </a:ext>
            </a:extLst>
          </p:cNvPr>
          <p:cNvSpPr txBox="1"/>
          <p:nvPr/>
        </p:nvSpPr>
        <p:spPr>
          <a:xfrm>
            <a:off x="93663" y="215900"/>
            <a:ext cx="3736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CA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3 Reagents and Antibodies</a:t>
            </a:r>
            <a:endParaRPr kumimoji="1" lang="ja-CA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E873EF98-4E37-5DE4-25C2-F1A8F18AAB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7131138"/>
              </p:ext>
            </p:extLst>
          </p:nvPr>
        </p:nvGraphicFramePr>
        <p:xfrm>
          <a:off x="93662" y="706438"/>
          <a:ext cx="6281738" cy="7899452"/>
        </p:xfrm>
        <a:graphic>
          <a:graphicData uri="http://schemas.openxmlformats.org/drawingml/2006/table">
            <a:tbl>
              <a:tblPr>
                <a:tableStyleId>{EB344D84-9AFB-497E-A393-DC336BA19D2E}</a:tableStyleId>
              </a:tblPr>
              <a:tblGrid>
                <a:gridCol w="1866042">
                  <a:extLst>
                    <a:ext uri="{9D8B030D-6E8A-4147-A177-3AD203B41FA5}">
                      <a16:colId xmlns:a16="http://schemas.microsoft.com/office/drawing/2014/main" val="201120628"/>
                    </a:ext>
                  </a:extLst>
                </a:gridCol>
                <a:gridCol w="921700">
                  <a:extLst>
                    <a:ext uri="{9D8B030D-6E8A-4147-A177-3AD203B41FA5}">
                      <a16:colId xmlns:a16="http://schemas.microsoft.com/office/drawing/2014/main" val="3181866261"/>
                    </a:ext>
                  </a:extLst>
                </a:gridCol>
                <a:gridCol w="515846">
                  <a:extLst>
                    <a:ext uri="{9D8B030D-6E8A-4147-A177-3AD203B41FA5}">
                      <a16:colId xmlns:a16="http://schemas.microsoft.com/office/drawing/2014/main" val="155685527"/>
                    </a:ext>
                  </a:extLst>
                </a:gridCol>
                <a:gridCol w="361950">
                  <a:extLst>
                    <a:ext uri="{9D8B030D-6E8A-4147-A177-3AD203B41FA5}">
                      <a16:colId xmlns:a16="http://schemas.microsoft.com/office/drawing/2014/main" val="3397414355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177855843"/>
                    </a:ext>
                  </a:extLst>
                </a:gridCol>
                <a:gridCol w="431800">
                  <a:extLst>
                    <a:ext uri="{9D8B030D-6E8A-4147-A177-3AD203B41FA5}">
                      <a16:colId xmlns:a16="http://schemas.microsoft.com/office/drawing/2014/main" val="1314952945"/>
                    </a:ext>
                  </a:extLst>
                </a:gridCol>
                <a:gridCol w="443836">
                  <a:extLst>
                    <a:ext uri="{9D8B030D-6E8A-4147-A177-3AD203B41FA5}">
                      <a16:colId xmlns:a16="http://schemas.microsoft.com/office/drawing/2014/main" val="3289816203"/>
                    </a:ext>
                  </a:extLst>
                </a:gridCol>
                <a:gridCol w="387682">
                  <a:extLst>
                    <a:ext uri="{9D8B030D-6E8A-4147-A177-3AD203B41FA5}">
                      <a16:colId xmlns:a16="http://schemas.microsoft.com/office/drawing/2014/main" val="1344678321"/>
                    </a:ext>
                  </a:extLst>
                </a:gridCol>
                <a:gridCol w="387682">
                  <a:extLst>
                    <a:ext uri="{9D8B030D-6E8A-4147-A177-3AD203B41FA5}">
                      <a16:colId xmlns:a16="http://schemas.microsoft.com/office/drawing/2014/main" val="3226660142"/>
                    </a:ext>
                  </a:extLst>
                </a:gridCol>
              </a:tblGrid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/reagent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any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alog </a:t>
                      </a:r>
                    </a:p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lution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econdary Antibody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jugate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any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alog #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lution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0267152"/>
                  </a:ext>
                </a:extLst>
              </a:tr>
              <a:tr h="20213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</a:t>
                      </a:r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SN</a:t>
                      </a:r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ntibody mouse monoclonal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vus Biologicals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B110-10067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</a:t>
                      </a:r>
                      <a:endParaRPr lang="en-US" altLang="ja-C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nkey anti-Mouse IgG (H+L) Highly Cross-Adsorbed Secondary Antibody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exa Fluor™ Plus 488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vitrogen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32766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056903076"/>
                  </a:ext>
                </a:extLst>
              </a:tr>
              <a:tr h="20213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NCR1 antibody rabbit polyclonal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214468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</a:t>
                      </a:r>
                      <a:endParaRPr lang="en-US" altLang="ja-C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at anti-Rabbit IgG (H+L) Highly Cross-Adsorbed Secondary Antibody, Alexa Fluor™ 647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exa Fluor™ 647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vitrogen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21245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altLang="ja-C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227275692"/>
                  </a:ext>
                </a:extLst>
              </a:tr>
              <a:tr h="20213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Keratin K8/K18 guinea pig polyclonal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GEN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11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</a:t>
                      </a:r>
                      <a:endParaRPr lang="en-US" altLang="ja-C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at anti-Guinea Pig IgG (H+L) Highly Cross-Adsorbed Secondary Antibody, Alexa Fluor™ 568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exa Fluor™ 568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vitrogen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11075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altLang="ja-C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3425613311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ctor TrueVIEW Autofluorescence Quenching Kit with DAPI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CTOR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CTSP8500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3266100472"/>
                  </a:ext>
                </a:extLst>
              </a:tr>
              <a:tr h="20213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 pGSN Antibody mouse monoclonal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ma-Aldrich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B4200750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at Anti-mouse IgG (H+L)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P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-Rad (Mississauga, Canada)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0-6516</a:t>
                      </a:r>
                      <a:endParaRPr lang="en-US" altLang="ja-C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2000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2472661075"/>
                  </a:ext>
                </a:extLst>
              </a:tr>
              <a:tr h="20213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GAPDH antibody rabbit monoclonal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18160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5000</a:t>
                      </a:r>
                      <a:endParaRPr lang="en-US" altLang="ja-C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at Anti-rabbit IgG (H+L)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P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-Rad (Mississauga, Canada)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0-6515</a:t>
                      </a:r>
                      <a:endParaRPr lang="en-US" altLang="ja-C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2000</a:t>
                      </a:r>
                      <a:endParaRPr lang="en-US" altLang="ja-C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2089593087"/>
                  </a:ext>
                </a:extLst>
              </a:tr>
              <a:tr h="20213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-Cleaved Caspase-3 (Asp175) Antibody  rabitt poly clonal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61S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altLang="ja-C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at Anti-rabbit IgG (H+L)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P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-Rad (Mississauga, Canada)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0-6515</a:t>
                      </a:r>
                      <a:endParaRPr lang="en-US" altLang="ja-C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2000</a:t>
                      </a:r>
                      <a:endParaRPr lang="en-US" altLang="ja-C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2916607815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3774960211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226718671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FN-</a:t>
                      </a:r>
                      <a:r>
                        <a:rPr lang="el-GR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γ </a:t>
                      </a:r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, anti-human, FITC, </a:t>
                      </a:r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finity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ltenyi Biotec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0-113-497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3790694928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BioscienceTM</a:t>
                      </a:r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nnexin V-FITC Apoptosis Detection Kit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vitrogen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MS500FI-300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4178410029"/>
                  </a:ext>
                </a:extLst>
              </a:tr>
              <a:tr h="96583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Trace™ Far Red Cell Proliferation Kit, for flow cytometry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vitrogen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34564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443528247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illiant Violet 605™ anti-human CD279 (PD-1) Antibody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9923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2747176869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illiant Violet 711™ anti-human TIGIT (VSTM3) Antibody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2741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2257011894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illiant Violet 421™ anti-human CD335 (NKp46) Antibody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1913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115017628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illiant Violet 785™ anti-human CD223 (LAG-3) Antibody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9321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1577168556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CP</a:t>
                      </a:r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Cyanine5.5 anti-human CD45 Antibody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4027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727338524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/Cyanine7 anti-human CD152 (CTLA-4) Antibody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9613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1621539776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C anti-human CD366 (Tim-3) Antibody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5011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1254208913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ombie NIR™ Fixable Viability Kit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3105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1074520717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Zombie Violet™ Fixable Viability Kit</a:t>
                      </a: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23113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3993167852"/>
                  </a:ext>
                </a:extLst>
              </a:tr>
              <a:tr h="169458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Brilliant Violet 421™ anti-STAT3 </a:t>
                      </a:r>
                      <a:r>
                        <a:rPr lang="en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Phospho</a:t>
                      </a:r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 (Tyr705) Antibody</a:t>
                      </a: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51009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3466352006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Brilliant Violet 510™ anti-human CD45 Antibody</a:t>
                      </a: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68525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552711929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Alexa Fluor® 647 anti-human CD335 (NKp46) Antibody</a:t>
                      </a: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31909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1466333577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Brilliant Violet 711™ anti-human CD366 (Tim-3) Antibody</a:t>
                      </a: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45023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3699101625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Brilliant Violet 605™ anti-T-bet Antibody</a:t>
                      </a: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44817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1766520508"/>
                  </a:ext>
                </a:extLst>
              </a:tr>
              <a:tr h="91984">
                <a:tc>
                  <a:txBody>
                    <a:bodyPr/>
                    <a:lstStyle/>
                    <a:p>
                      <a:pPr algn="l" fontAlgn="ctr"/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Gelsolin Polyclonal Antibody, PE Conjugated</a:t>
                      </a: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Bioss</a:t>
                      </a:r>
                      <a:r>
                        <a:rPr lang="e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 Antibodies</a:t>
                      </a: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C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S-1160R-PE</a:t>
                      </a:r>
                      <a:endParaRPr lang="en-US" altLang="ja-C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CA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3449" marR="3449" marT="3449" marB="0" anchor="ctr"/>
                </a:tc>
                <a:extLst>
                  <a:ext uri="{0D108BD9-81ED-4DB2-BD59-A6C34878D82A}">
                    <a16:rowId xmlns:a16="http://schemas.microsoft.com/office/drawing/2014/main" val="12765934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189398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C3C0C336-5D51-9BDA-5ED0-A10CB40984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0377620"/>
              </p:ext>
            </p:extLst>
          </p:nvPr>
        </p:nvGraphicFramePr>
        <p:xfrm>
          <a:off x="582613" y="857250"/>
          <a:ext cx="4736170" cy="1258198"/>
        </p:xfrm>
        <a:graphic>
          <a:graphicData uri="http://schemas.openxmlformats.org/drawingml/2006/table">
            <a:tbl>
              <a:tblPr>
                <a:tableStyleId>{EB344D84-9AFB-497E-A393-DC336BA19D2E}</a:tableStyleId>
              </a:tblPr>
              <a:tblGrid>
                <a:gridCol w="851829">
                  <a:extLst>
                    <a:ext uri="{9D8B030D-6E8A-4147-A177-3AD203B41FA5}">
                      <a16:colId xmlns:a16="http://schemas.microsoft.com/office/drawing/2014/main" val="1733366954"/>
                    </a:ext>
                  </a:extLst>
                </a:gridCol>
                <a:gridCol w="2019958">
                  <a:extLst>
                    <a:ext uri="{9D8B030D-6E8A-4147-A177-3AD203B41FA5}">
                      <a16:colId xmlns:a16="http://schemas.microsoft.com/office/drawing/2014/main" val="1654344346"/>
                    </a:ext>
                  </a:extLst>
                </a:gridCol>
                <a:gridCol w="1012554">
                  <a:extLst>
                    <a:ext uri="{9D8B030D-6E8A-4147-A177-3AD203B41FA5}">
                      <a16:colId xmlns:a16="http://schemas.microsoft.com/office/drawing/2014/main" val="312120585"/>
                    </a:ext>
                  </a:extLst>
                </a:gridCol>
                <a:gridCol w="851829">
                  <a:extLst>
                    <a:ext uri="{9D8B030D-6E8A-4147-A177-3AD203B41FA5}">
                      <a16:colId xmlns:a16="http://schemas.microsoft.com/office/drawing/2014/main" val="92889195"/>
                    </a:ext>
                  </a:extLst>
                </a:gridCol>
              </a:tblGrid>
              <a:tr h="243840"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line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origin</a:t>
                      </a:r>
                      <a:endParaRPr lang="en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53 status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mosensitivity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4977768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2780S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arian Endometrioid carcinoma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ld type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nsitive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216149329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2780CP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arian Endometrioid carcinoma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tant V127F, R260S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stant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/>
                </a:tc>
                <a:extLst>
                  <a:ext uri="{0D108BD9-81ED-4DB2-BD59-A6C34878D82A}">
                    <a16:rowId xmlns:a16="http://schemas.microsoft.com/office/drawing/2014/main" val="255449578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V3041G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arian Serous carcinoma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ld type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nsitive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/>
                </a:tc>
                <a:extLst>
                  <a:ext uri="{0D108BD9-81ED-4DB2-BD59-A6C34878D82A}">
                    <a16:rowId xmlns:a16="http://schemas.microsoft.com/office/drawing/2014/main" val="3568229937"/>
                  </a:ext>
                </a:extLst>
              </a:tr>
              <a:tr h="243840"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90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arian Serous carcinoma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tant Ser215Arg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9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stant</a:t>
                      </a:r>
                      <a:endParaRPr lang="en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8518" marR="8518" marT="8518" marB="0" anchor="ctr"/>
                </a:tc>
                <a:extLst>
                  <a:ext uri="{0D108BD9-81ED-4DB2-BD59-A6C34878D82A}">
                    <a16:rowId xmlns:a16="http://schemas.microsoft.com/office/drawing/2014/main" val="2784675692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1077CF1-BDE5-6E61-8A98-737BF4540912}"/>
              </a:ext>
            </a:extLst>
          </p:cNvPr>
          <p:cNvSpPr txBox="1"/>
          <p:nvPr/>
        </p:nvSpPr>
        <p:spPr>
          <a:xfrm>
            <a:off x="131763" y="367457"/>
            <a:ext cx="3736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CA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4 Characteristic of cell lines</a:t>
            </a:r>
            <a:endParaRPr kumimoji="1" lang="ja-CA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D109FCB0-5C58-652B-4C27-543DF71E285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0528431"/>
              </p:ext>
            </p:extLst>
          </p:nvPr>
        </p:nvGraphicFramePr>
        <p:xfrm>
          <a:off x="446087" y="3673221"/>
          <a:ext cx="5588000" cy="4471497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3855287">
                  <a:extLst>
                    <a:ext uri="{9D8B030D-6E8A-4147-A177-3AD203B41FA5}">
                      <a16:colId xmlns:a16="http://schemas.microsoft.com/office/drawing/2014/main" val="2116910571"/>
                    </a:ext>
                  </a:extLst>
                </a:gridCol>
                <a:gridCol w="1732713">
                  <a:extLst>
                    <a:ext uri="{9D8B030D-6E8A-4147-A177-3AD203B41FA5}">
                      <a16:colId xmlns:a16="http://schemas.microsoft.com/office/drawing/2014/main" val="135103444"/>
                    </a:ext>
                  </a:extLst>
                </a:gridCol>
              </a:tblGrid>
              <a:tr h="18410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ssue Marker Expression (MFI)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atients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06440702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case Epithelial NCR1 (Cut-off =898.2)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alt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29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8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624166950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residual case Epithelial NCR1 (Cut-off =365.4 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alt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45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56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51596799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case Epithelial NCR1 (Cut-off =</a:t>
                      </a:r>
                      <a:r>
                        <a:rPr kumimoji="1" lang="en-US" altLang="ja-JP" sz="9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2.0</a:t>
                      </a: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alt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4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2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744369143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case stromal NCR1 (Cut-off =</a:t>
                      </a:r>
                      <a:r>
                        <a:rPr kumimoji="1"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4.3</a:t>
                      </a: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alt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07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40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4216518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residual case stromal NCR1 (Cut-off =159.7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alt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49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52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120001356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case stromal NCR1 (Cut-off =151.7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alt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1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5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80917352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80A53A4-041B-5A6F-87D3-0E7219EEFFF8}"/>
              </a:ext>
            </a:extLst>
          </p:cNvPr>
          <p:cNvSpPr txBox="1"/>
          <p:nvPr/>
        </p:nvSpPr>
        <p:spPr>
          <a:xfrm>
            <a:off x="144463" y="2988810"/>
            <a:ext cx="4122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CA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5 NCR1 MFI cutoff value for PFS in survival analysis</a:t>
            </a:r>
            <a:endParaRPr kumimoji="1" lang="ja-CA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77C1222A-B883-4D76-A17D-C0C5DACF93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050" y="8376433"/>
            <a:ext cx="5756275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FI: mean fluorescent intensity; 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CR1: natural cytotoxicity triggering receptor 1; PFS: progression-free survival.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76015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D109FCB0-5C58-652B-4C27-543DF71E285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92458515"/>
              </p:ext>
            </p:extLst>
          </p:nvPr>
        </p:nvGraphicFramePr>
        <p:xfrm>
          <a:off x="375749" y="863799"/>
          <a:ext cx="5588000" cy="4471497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3855287">
                  <a:extLst>
                    <a:ext uri="{9D8B030D-6E8A-4147-A177-3AD203B41FA5}">
                      <a16:colId xmlns:a16="http://schemas.microsoft.com/office/drawing/2014/main" val="2116910571"/>
                    </a:ext>
                  </a:extLst>
                </a:gridCol>
                <a:gridCol w="1732713">
                  <a:extLst>
                    <a:ext uri="{9D8B030D-6E8A-4147-A177-3AD203B41FA5}">
                      <a16:colId xmlns:a16="http://schemas.microsoft.com/office/drawing/2014/main" val="135103444"/>
                    </a:ext>
                  </a:extLst>
                </a:gridCol>
              </a:tblGrid>
              <a:tr h="18410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ssue Marker Expression (MFI)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atients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06440702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case epithelial </a:t>
                      </a:r>
                      <a:r>
                        <a:rPr lang="en-US" sz="9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SN</a:t>
                      </a: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Cut-off =150.3.)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23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24</a:t>
                      </a: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624166950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residual case epithelial </a:t>
                      </a:r>
                      <a:r>
                        <a:rPr lang="en-US" sz="9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SN</a:t>
                      </a: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Cut-off =140.1 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7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84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51596799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case epithelial </a:t>
                      </a:r>
                      <a:r>
                        <a:rPr lang="en-US" sz="9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SN</a:t>
                      </a: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Cut-off =</a:t>
                      </a:r>
                      <a:r>
                        <a:rPr kumimoji="1"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4.4</a:t>
                      </a: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9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744369143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case stromal </a:t>
                      </a:r>
                      <a:r>
                        <a:rPr lang="en-US" sz="9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SN</a:t>
                      </a: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Cut-off =</a:t>
                      </a:r>
                      <a:r>
                        <a:rPr kumimoji="1"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7.3</a:t>
                      </a: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56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91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4216518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residual case stromal </a:t>
                      </a:r>
                      <a:r>
                        <a:rPr lang="en-US" sz="9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SN</a:t>
                      </a: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Cut-off =159.7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61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40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120001356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case stromal </a:t>
                      </a:r>
                      <a:r>
                        <a:rPr lang="en-US" sz="9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SN</a:t>
                      </a: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Cut-off =231.0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5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1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80917352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80A53A4-041B-5A6F-87D3-0E7219EEFFF8}"/>
              </a:ext>
            </a:extLst>
          </p:cNvPr>
          <p:cNvSpPr txBox="1"/>
          <p:nvPr/>
        </p:nvSpPr>
        <p:spPr>
          <a:xfrm>
            <a:off x="74125" y="179388"/>
            <a:ext cx="4122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CA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6 </a:t>
            </a:r>
            <a:r>
              <a:rPr kumimoji="1" lang="en-US" altLang="ja-CA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GSN</a:t>
            </a:r>
            <a:r>
              <a:rPr kumimoji="1" lang="en-US" altLang="ja-CA" sz="1000" b="1" dirty="0">
                <a:latin typeface="Arial" panose="020B0604020202020204" pitchFamily="34" charset="0"/>
                <a:cs typeface="Arial" panose="020B0604020202020204" pitchFamily="34" charset="0"/>
              </a:rPr>
              <a:t> cutoff value for PFS in survival analysis</a:t>
            </a:r>
            <a:endParaRPr kumimoji="1" lang="ja-CA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77C1222A-B883-4D76-A17D-C0C5DACF93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9712" y="5643955"/>
            <a:ext cx="5756275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FI: mean fluorescent intensity; </a:t>
            </a:r>
            <a:r>
              <a:rPr lang="en-US" altLang="ja-JP" sz="1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GSN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lasma gelsolin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PFS: progression-free survival.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50438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59BB8A9B-EB57-1DC0-CA8C-FAC29D7768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4139789"/>
              </p:ext>
            </p:extLst>
          </p:nvPr>
        </p:nvGraphicFramePr>
        <p:xfrm>
          <a:off x="347663" y="627847"/>
          <a:ext cx="5588000" cy="7888305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4211637">
                  <a:extLst>
                    <a:ext uri="{9D8B030D-6E8A-4147-A177-3AD203B41FA5}">
                      <a16:colId xmlns:a16="http://schemas.microsoft.com/office/drawing/2014/main" val="2116910571"/>
                    </a:ext>
                  </a:extLst>
                </a:gridCol>
                <a:gridCol w="1376363">
                  <a:extLst>
                    <a:ext uri="{9D8B030D-6E8A-4147-A177-3AD203B41FA5}">
                      <a16:colId xmlns:a16="http://schemas.microsoft.com/office/drawing/2014/main" val="135103444"/>
                    </a:ext>
                  </a:extLst>
                </a:gridCol>
              </a:tblGrid>
              <a:tr h="18410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ssue Marker Expression (MFI)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atients</a:t>
                      </a:r>
                      <a:endParaRPr lang="ja-CA" sz="9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064407022"/>
                  </a:ext>
                </a:extLst>
              </a:tr>
              <a:tr h="121909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case Epithelial NCR1 (Cut-off =761.3 )/ Epithelial pGSN (Cut-off =224.9 ) 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pGSN/High NCR1 cells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pGSN/High NCR1 cells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pGSN/Low NCR1 cells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pGSN/Low NCR1 cells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7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7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86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7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156030400"/>
                  </a:ext>
                </a:extLst>
              </a:tr>
              <a:tr h="121909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residual case Epithelial NCR1 (Cut-off =365.4 )/ Epithelial pGSN (Cut-off =255.6 )  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pGSN/High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pGSN/High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pGSN/Low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pGSN/Low NCR1 cells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1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25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4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2897569003"/>
                  </a:ext>
                </a:extLst>
              </a:tr>
              <a:tr h="121909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case Epithelial NCR1 (Cut-off =602.0 )/ Epithelial pGSN (Cut-off =209.8 )  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pGSN/High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pGSN/High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pGSN/Low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pGSN/Low NCR1 cells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21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3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2673355568"/>
                  </a:ext>
                </a:extLst>
              </a:tr>
              <a:tr h="121909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case Stromal NCR1 (Cut-off =204.3 )/ Stromal pGSN (Cut-off =167.3 )  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pGSN/High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pGSN/High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pGSN/Low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pGSN/Low NCR1 cells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5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51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56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582064842"/>
                  </a:ext>
                </a:extLst>
              </a:tr>
              <a:tr h="121909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residual case Stromal NCR1 (Cut-off =159.7)/ Stromal pGSN (Cut-off =195.2 )  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pGSN/High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pGSN/High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pGSN/Low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pGSN/Low NCR1 cells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25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27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6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3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603894485"/>
                  </a:ext>
                </a:extLst>
              </a:tr>
              <a:tr h="121909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case Stromal NCR1 (Cut-off = 151.7)/ Stromal pGSN (Cut-off =167.3 )  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pGSN/High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pGSN/High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pGSN/Low NCR1 cells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pGSN/Low NCR1 cells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25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6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4272193096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25650C6-BA8F-8A49-272B-16896AD0517F}"/>
              </a:ext>
            </a:extLst>
          </p:cNvPr>
          <p:cNvSpPr txBox="1"/>
          <p:nvPr/>
        </p:nvSpPr>
        <p:spPr>
          <a:xfrm>
            <a:off x="93663" y="215900"/>
            <a:ext cx="44783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CA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7 NCR1 and pGSN MFI cutoff value for PFS in survival analysis</a:t>
            </a:r>
            <a:endParaRPr kumimoji="1" lang="ja-CA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0464818F-1B28-90DA-729E-5374A98374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050" y="8624083"/>
            <a:ext cx="5756275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FI: mean fluorescent intensity; pGSN: plasma gelsolin; 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CR1: natural cytotoxicity triggering receptor 1; PFS: progression-free survival.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23359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A42713DA-AE33-BA48-9CBD-DCB78997ECD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5606159"/>
              </p:ext>
            </p:extLst>
          </p:nvPr>
        </p:nvGraphicFramePr>
        <p:xfrm>
          <a:off x="409575" y="1415757"/>
          <a:ext cx="5588000" cy="4471497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3855287">
                  <a:extLst>
                    <a:ext uri="{9D8B030D-6E8A-4147-A177-3AD203B41FA5}">
                      <a16:colId xmlns:a16="http://schemas.microsoft.com/office/drawing/2014/main" val="2116910571"/>
                    </a:ext>
                  </a:extLst>
                </a:gridCol>
                <a:gridCol w="1732713">
                  <a:extLst>
                    <a:ext uri="{9D8B030D-6E8A-4147-A177-3AD203B41FA5}">
                      <a16:colId xmlns:a16="http://schemas.microsoft.com/office/drawing/2014/main" val="135103444"/>
                    </a:ext>
                  </a:extLst>
                </a:gridCol>
              </a:tblGrid>
              <a:tr h="18410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ssue Marker Expression (MFI)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atients</a:t>
                      </a:r>
                      <a:endParaRPr lang="ja-CA" sz="9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06440702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case Epithelial NCR1 (Cut-off =215.7) 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alt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4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33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624166950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residual case Epithelial NCR1 (Cut-off =346.4)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alt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9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62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51596799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case Epithelial NCR1 (Cut-off =761.3)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43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744369143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 case stromal NCR1 (Cut-off =204.3)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07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40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4216518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residual case stromal NCR1 (Cut-off =159.7)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49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52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120001356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al case stromal NCR1 (Cut-off =205.4)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3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3</a:t>
                      </a:r>
                      <a:endParaRPr lang="ja-CA" sz="9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80917352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301447C-093E-30DC-4EF3-647035D2CD6B}"/>
              </a:ext>
            </a:extLst>
          </p:cNvPr>
          <p:cNvSpPr txBox="1"/>
          <p:nvPr/>
        </p:nvSpPr>
        <p:spPr>
          <a:xfrm>
            <a:off x="347663" y="292100"/>
            <a:ext cx="4122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CA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8 NCR1 MFI cutoff value for OS in survival analysis</a:t>
            </a:r>
            <a:endParaRPr kumimoji="1" lang="ja-CA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51929555-CDE6-7483-1A9E-F650A3A52D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437" y="6058683"/>
            <a:ext cx="5756275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FI: mean fluorescent intensity; 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CR1: natural cytotoxicity triggering receptor 1; PFS: progression-free survival.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18913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783BC49-40F0-F026-149A-2464E67EB3EE}"/>
              </a:ext>
            </a:extLst>
          </p:cNvPr>
          <p:cNvSpPr txBox="1"/>
          <p:nvPr/>
        </p:nvSpPr>
        <p:spPr>
          <a:xfrm>
            <a:off x="347663" y="292100"/>
            <a:ext cx="54181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CA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9 NCR1 MFI cutoff value of histological subtypes for PFS in survival analysis</a:t>
            </a:r>
            <a:endParaRPr kumimoji="1" lang="ja-CA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98D9742C-E03F-C591-10C1-93F05A83C8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4272354"/>
              </p:ext>
            </p:extLst>
          </p:nvPr>
        </p:nvGraphicFramePr>
        <p:xfrm>
          <a:off x="409575" y="1415757"/>
          <a:ext cx="5588000" cy="590062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3855287">
                  <a:extLst>
                    <a:ext uri="{9D8B030D-6E8A-4147-A177-3AD203B41FA5}">
                      <a16:colId xmlns:a16="http://schemas.microsoft.com/office/drawing/2014/main" val="2116910571"/>
                    </a:ext>
                  </a:extLst>
                </a:gridCol>
                <a:gridCol w="1732713">
                  <a:extLst>
                    <a:ext uri="{9D8B030D-6E8A-4147-A177-3AD203B41FA5}">
                      <a16:colId xmlns:a16="http://schemas.microsoft.com/office/drawing/2014/main" val="135103444"/>
                    </a:ext>
                  </a:extLst>
                </a:gridCol>
              </a:tblGrid>
              <a:tr h="18410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ssue Marker Expression (MFI)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atients</a:t>
                      </a:r>
                      <a:endParaRPr lang="ja-CA" sz="9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06440702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ous Epithelial NCR1 (Cut-off =809.6)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alt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62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624166950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metrioid case Epithelial NCR1 (Cut-off =334.6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alt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3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51596799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ear cell Epithelial NCR1 (Cut-off =642.2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2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8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744369143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cinous Epithelial NCR1 (Cut-off =371.9)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3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898075534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ous stromal NCR1 (Cut-off =148.0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20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50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4216518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metrioid  stromal NCR1 (Cut-off =178.5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1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0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120001356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ear cell stromal NCR1 (Cut-off =192.9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25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5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8091735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cinous Stromal NCR1 (Cut-off =137.5 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2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1468975945"/>
                  </a:ext>
                </a:extLst>
              </a:tr>
            </a:tbl>
          </a:graphicData>
        </a:graphic>
      </p:graphicFrame>
      <p:sp>
        <p:nvSpPr>
          <p:cNvPr id="4" name="Rectangle 2">
            <a:extLst>
              <a:ext uri="{FF2B5EF4-FFF2-40B4-BE49-F238E27FC236}">
                <a16:creationId xmlns:a16="http://schemas.microsoft.com/office/drawing/2014/main" id="{0138A6E9-16F9-B1F3-F3EE-0CF0FD00D0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1949" y="7442983"/>
            <a:ext cx="5756275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FI: mean fluorescent intensity; 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CR1: natural cytotoxicity triggering receptor 1; PFS: progression-free survival.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9891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783BC49-40F0-F026-149A-2464E67EB3EE}"/>
              </a:ext>
            </a:extLst>
          </p:cNvPr>
          <p:cNvSpPr txBox="1"/>
          <p:nvPr/>
        </p:nvSpPr>
        <p:spPr>
          <a:xfrm>
            <a:off x="347663" y="292100"/>
            <a:ext cx="54181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CA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10 NCR1 MFI cutoff value of histological subtypes for OS  in survival analysis</a:t>
            </a:r>
            <a:endParaRPr kumimoji="1" lang="ja-CA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98D9742C-E03F-C591-10C1-93F05A83C8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8857954"/>
              </p:ext>
            </p:extLst>
          </p:nvPr>
        </p:nvGraphicFramePr>
        <p:xfrm>
          <a:off x="409575" y="1415757"/>
          <a:ext cx="5588000" cy="590062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3855287">
                  <a:extLst>
                    <a:ext uri="{9D8B030D-6E8A-4147-A177-3AD203B41FA5}">
                      <a16:colId xmlns:a16="http://schemas.microsoft.com/office/drawing/2014/main" val="2116910571"/>
                    </a:ext>
                  </a:extLst>
                </a:gridCol>
                <a:gridCol w="1732713">
                  <a:extLst>
                    <a:ext uri="{9D8B030D-6E8A-4147-A177-3AD203B41FA5}">
                      <a16:colId xmlns:a16="http://schemas.microsoft.com/office/drawing/2014/main" val="135103444"/>
                    </a:ext>
                  </a:extLst>
                </a:gridCol>
              </a:tblGrid>
              <a:tr h="184101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ssue Marker Expression (MFI)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atients</a:t>
                      </a:r>
                      <a:endParaRPr lang="ja-CA" sz="9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06440702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ous Epithelial NCR1 (Cut-off =229.8)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alt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66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624166950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metrioid case Epithelial NCR1 (Cut-off =911.4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alt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51596799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ear cell Epithelial NCR1 (Cut-off =571.9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0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0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744369143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cinous Epithelial NCR1 (Cut-off =371.9)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alt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altLang="ja-CA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3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898075534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ous stromal NCR1 (Cut-off =131.7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61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4216518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ometrioid  stromal NCR1 (Cut-off =265.0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7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4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120001356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ear cell stromal NCR1 (Cut-off =192.9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25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5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380917352"/>
                  </a:ext>
                </a:extLst>
              </a:tr>
              <a:tr h="679549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cinous Stromal NCR1 (Cut-off =214.4 )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</a:t>
                      </a:r>
                      <a:endParaRPr lang="ja-CA" sz="9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13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ja-CA" sz="9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4977" marR="64977" marT="0" marB="0"/>
                </a:tc>
                <a:extLst>
                  <a:ext uri="{0D108BD9-81ED-4DB2-BD59-A6C34878D82A}">
                    <a16:rowId xmlns:a16="http://schemas.microsoft.com/office/drawing/2014/main" val="1468975945"/>
                  </a:ext>
                </a:extLst>
              </a:tr>
            </a:tbl>
          </a:graphicData>
        </a:graphic>
      </p:graphicFrame>
      <p:sp>
        <p:nvSpPr>
          <p:cNvPr id="4" name="Rectangle 2">
            <a:extLst>
              <a:ext uri="{FF2B5EF4-FFF2-40B4-BE49-F238E27FC236}">
                <a16:creationId xmlns:a16="http://schemas.microsoft.com/office/drawing/2014/main" id="{10E0AF87-5E59-04A6-660C-978F220B7A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7663" y="7474733"/>
            <a:ext cx="5756275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FI: mean fluorescent intensity; 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CR1: natural cytotoxicity triggering receptor 1; PFS: progression-free survival.</a:t>
            </a:r>
            <a:endParaRPr kumimoji="0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07586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79</TotalTime>
  <Words>1951</Words>
  <Application>Microsoft Macintosh PowerPoint</Application>
  <PresentationFormat>ユーザー設定</PresentationFormat>
  <Paragraphs>665</Paragraphs>
  <Slides>10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numa Toshimichi</dc:creator>
  <cp:lastModifiedBy>Toshimichi Onuma</cp:lastModifiedBy>
  <cp:revision>53</cp:revision>
  <cp:lastPrinted>2022-09-10T16:26:01Z</cp:lastPrinted>
  <dcterms:created xsi:type="dcterms:W3CDTF">2022-09-06T17:38:57Z</dcterms:created>
  <dcterms:modified xsi:type="dcterms:W3CDTF">2024-05-16T09:53:22Z</dcterms:modified>
</cp:coreProperties>
</file>